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993F4-610E-4019-8A9A-F9DCEC7946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08EFE-6161-44A8-ABF6-BDBD4B0A98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72121-87CF-48B3-9B1E-D4A9970B54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5A208-7BD3-42C2-B772-7B04171F2A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F1741-0094-4D31-9725-D5797DB2AC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4992BD-A76E-4E1C-B3A5-F375D17E20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461D1-8C9B-47E1-9DD5-8E7FAAAF75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705DD-3F5C-41FF-9247-CEC7AD83F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E2940-71D8-4C54-A0BB-4928BCF294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7E16E-7F23-47BC-B564-2E1DF6734A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8E395-D0DE-4104-A09B-8F4B43F1E6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72CAA-CA30-48D5-88D8-AC1D8DC2ED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90ED69-5695-4E1C-99C4-8AA5C0DD7AC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04640" y="1187280"/>
            <a:ext cx="5674680" cy="3168720"/>
            <a:chOff x="404640" y="1187280"/>
            <a:chExt cx="5674680" cy="3168720"/>
          </a:xfrm>
        </p:grpSpPr>
        <p:grpSp>
          <p:nvGrpSpPr>
            <p:cNvPr id="42" name=""/>
            <p:cNvGrpSpPr/>
            <p:nvPr/>
          </p:nvGrpSpPr>
          <p:grpSpPr>
            <a:xfrm>
              <a:off x="477000" y="1260360"/>
              <a:ext cx="5602320" cy="1433520"/>
              <a:chOff x="477000" y="1260360"/>
              <a:chExt cx="5602320" cy="143352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478080" y="1655640"/>
                <a:ext cx="1280160" cy="1038240"/>
                <a:chOff x="478080" y="1655640"/>
                <a:chExt cx="1280160" cy="1038240"/>
              </a:xfrm>
            </p:grpSpPr>
            <p:sp>
              <p:nvSpPr>
                <p:cNvPr id="44" name=""/>
                <p:cNvSpPr/>
                <p:nvPr/>
              </p:nvSpPr>
              <p:spPr>
                <a:xfrm>
                  <a:off x="620640" y="1726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"/>
                <p:cNvSpPr/>
                <p:nvPr/>
              </p:nvSpPr>
              <p:spPr>
                <a:xfrm>
                  <a:off x="765000" y="2014200"/>
                  <a:ext cx="647640" cy="6494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981000" y="1726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622440" y="2447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478080" y="1655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1486080" y="165564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838440" y="2158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983520" y="179820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981000" y="2087280"/>
                  <a:ext cx="431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623160" y="187128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982800" y="2374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1343160" y="187128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1198800" y="2158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7" name=""/>
              <p:cNvSpPr/>
              <p:nvPr/>
            </p:nvSpPr>
            <p:spPr>
              <a:xfrm>
                <a:off x="2133360" y="1726920"/>
                <a:ext cx="64800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278080" y="2014200"/>
                <a:ext cx="647640" cy="6494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493720" y="1726920"/>
                <a:ext cx="64800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135160" y="2447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990800" y="1655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999160" y="16556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351160" y="2158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496240" y="179820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493720" y="2087280"/>
                <a:ext cx="43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135880" y="18712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496240" y="23745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856240" y="18712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711520" y="2158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941720" y="1726920"/>
                <a:ext cx="64764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5086080" y="2014200"/>
                <a:ext cx="648000" cy="6494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302080" y="1726920"/>
                <a:ext cx="64764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943520" y="2447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799160" y="1655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807160" y="16556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159520" y="2158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304600" y="179820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229000" y="205380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944240" y="18712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304600" y="23745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664240" y="18712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5519880" y="2158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3" name=""/>
              <p:cNvGrpSpPr/>
              <p:nvPr/>
            </p:nvGrpSpPr>
            <p:grpSpPr>
              <a:xfrm>
                <a:off x="3359160" y="1655640"/>
                <a:ext cx="1280160" cy="1038240"/>
                <a:chOff x="3359160" y="1655640"/>
                <a:chExt cx="1280160" cy="1038240"/>
              </a:xfrm>
            </p:grpSpPr>
            <p:sp>
              <p:nvSpPr>
                <p:cNvPr id="84" name=""/>
                <p:cNvSpPr/>
                <p:nvPr/>
              </p:nvSpPr>
              <p:spPr>
                <a:xfrm>
                  <a:off x="3501720" y="1726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3646080" y="2014200"/>
                  <a:ext cx="647640" cy="6494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3862080" y="1726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3503520" y="2447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3359160" y="1655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4367160" y="165564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3719520" y="2158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3864600" y="179820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3862080" y="2087280"/>
                  <a:ext cx="431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3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3504240" y="187128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3863880" y="2374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4224240" y="187128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4079880" y="2158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7" name=""/>
              <p:cNvSpPr/>
              <p:nvPr/>
            </p:nvSpPr>
            <p:spPr>
              <a:xfrm>
                <a:off x="477000" y="1260360"/>
                <a:ext cx="1669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himp sequence exclud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77360" y="1404720"/>
                <a:ext cx="92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Mouse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989000" y="1404720"/>
                <a:ext cx="74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Rat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871160" y="1402920"/>
                <a:ext cx="910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himp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430800" y="1402920"/>
                <a:ext cx="953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Human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428640" y="1260360"/>
                <a:ext cx="168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Mouse sequence exclud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"/>
            <p:cNvGrpSpPr/>
            <p:nvPr/>
          </p:nvGrpSpPr>
          <p:grpSpPr>
            <a:xfrm>
              <a:off x="415440" y="2844360"/>
              <a:ext cx="5603400" cy="1433520"/>
              <a:chOff x="415440" y="2844360"/>
              <a:chExt cx="5603400" cy="1433520"/>
            </a:xfrm>
          </p:grpSpPr>
          <p:grpSp>
            <p:nvGrpSpPr>
              <p:cNvPr id="104" name=""/>
              <p:cNvGrpSpPr/>
              <p:nvPr/>
            </p:nvGrpSpPr>
            <p:grpSpPr>
              <a:xfrm>
                <a:off x="417600" y="3239640"/>
                <a:ext cx="1280160" cy="1038240"/>
                <a:chOff x="417600" y="3239640"/>
                <a:chExt cx="1280160" cy="1038240"/>
              </a:xfrm>
            </p:grpSpPr>
            <p:sp>
              <p:nvSpPr>
                <p:cNvPr id="105" name=""/>
                <p:cNvSpPr/>
                <p:nvPr/>
              </p:nvSpPr>
              <p:spPr>
                <a:xfrm>
                  <a:off x="560160" y="3310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704520" y="3598200"/>
                  <a:ext cx="647640" cy="6494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920520" y="3310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561960" y="4031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417600" y="3239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1425600" y="323964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777960" y="3742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923040" y="338220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920520" y="3671280"/>
                  <a:ext cx="431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4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562680" y="345528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923040" y="395856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1282680" y="345528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1138320" y="3742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8" name=""/>
              <p:cNvSpPr/>
              <p:nvPr/>
            </p:nvSpPr>
            <p:spPr>
              <a:xfrm>
                <a:off x="2072880" y="3310920"/>
                <a:ext cx="64800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217600" y="3598200"/>
                <a:ext cx="647640" cy="6494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433240" y="3310920"/>
                <a:ext cx="64800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074680" y="4031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1930320" y="3239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938680" y="32396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290680" y="3742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435760" y="338220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433240" y="3671280"/>
                <a:ext cx="43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4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075400" y="34552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435760" y="39585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795760" y="34552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651040" y="3742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881240" y="3310920"/>
                <a:ext cx="64764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5025600" y="3598200"/>
                <a:ext cx="648000" cy="6494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5241600" y="3310920"/>
                <a:ext cx="647640" cy="647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883040" y="4031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738680" y="323964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5746680" y="32396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5099040" y="3742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5244120" y="338220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5168520" y="363780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883760" y="34552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244120" y="39585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603760" y="34552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5459400" y="37425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4" name=""/>
              <p:cNvGrpSpPr/>
              <p:nvPr/>
            </p:nvGrpSpPr>
            <p:grpSpPr>
              <a:xfrm>
                <a:off x="3298680" y="3239640"/>
                <a:ext cx="1280160" cy="1038240"/>
                <a:chOff x="3298680" y="3239640"/>
                <a:chExt cx="1280160" cy="1038240"/>
              </a:xfrm>
            </p:grpSpPr>
            <p:sp>
              <p:nvSpPr>
                <p:cNvPr id="145" name=""/>
                <p:cNvSpPr/>
                <p:nvPr/>
              </p:nvSpPr>
              <p:spPr>
                <a:xfrm>
                  <a:off x="3441240" y="3310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3585600" y="3598200"/>
                  <a:ext cx="647640" cy="6494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3801600" y="3310920"/>
                  <a:ext cx="647640" cy="647640"/>
                </a:xfrm>
                <a:prstGeom prst="ellips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3443040" y="4031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3298680" y="3239640"/>
                  <a:ext cx="264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4306680" y="323964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3659040" y="374256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3804120" y="338220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3801600" y="3671280"/>
                  <a:ext cx="431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2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3443760" y="345528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3804120" y="395856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4163760" y="345528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4020120" y="374256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8" name=""/>
              <p:cNvSpPr/>
              <p:nvPr/>
            </p:nvSpPr>
            <p:spPr>
              <a:xfrm>
                <a:off x="415440" y="2844360"/>
                <a:ext cx="1537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Dog sequence exclud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16880" y="2988720"/>
                <a:ext cx="92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Mouse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1928520" y="2988720"/>
                <a:ext cx="74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Rat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810680" y="2986920"/>
                <a:ext cx="910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himp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3370320" y="2986920"/>
                <a:ext cx="953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Human PSG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3368520" y="2844360"/>
                <a:ext cx="183960" cy="24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4" name=""/>
            <p:cNvSpPr/>
            <p:nvPr/>
          </p:nvSpPr>
          <p:spPr>
            <a:xfrm>
              <a:off x="404640" y="1187280"/>
              <a:ext cx="5616720" cy="3168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5" name=""/>
          <p:cNvSpPr/>
          <p:nvPr/>
        </p:nvSpPr>
        <p:spPr>
          <a:xfrm>
            <a:off x="888840" y="459108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1T15:52:51Z</dcterms:created>
  <dc:creator>Ziheng Yang</dc:creator>
  <dc:description/>
  <dc:language>en-US</dc:language>
  <cp:lastModifiedBy>Ziheng Yang</cp:lastModifiedBy>
  <dcterms:modified xsi:type="dcterms:W3CDTF">2008-01-31T15:53:09Z</dcterms:modified>
  <cp:revision>1</cp:revision>
  <dc:subject/>
  <dc:title>Slide 1</dc:title>
</cp:coreProperties>
</file>